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12" y="188640"/>
            <a:ext cx="5561534" cy="642267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868144" y="1556792"/>
            <a:ext cx="3168351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ure</a:t>
            </a:r>
            <a:r>
              <a:rPr lang="en-US" altLang="zh-CN" sz="14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.</a:t>
            </a:r>
            <a:r>
              <a:rPr lang="en-US" altLang="zh-CN" sz="14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4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8</a:t>
            </a:r>
            <a:r>
              <a:rPr lang="en-US" altLang="zh-CN" sz="14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Quantitative 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real-time PCR (</a:t>
            </a:r>
            <a:r>
              <a:rPr lang="en-US" altLang="zh-CN" sz="1400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qRT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-PCR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r>
              <a:rPr lang="en-US" altLang="zh-CN" sz="1400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f gene expression profiles of differentially expressed genes.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g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,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nd </a:t>
            </a:r>
            <a:r>
              <a:rPr lang="en-US" altLang="zh-CN" sz="1400" b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i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indicate nearly the same gene expression patterns between Microarray and </a:t>
            </a:r>
            <a:r>
              <a:rPr lang="en-US" altLang="zh-CN" sz="1400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qRT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-PCR results.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j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showed different tendency in Group II.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k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and </a:t>
            </a:r>
            <a:r>
              <a:rPr lang="en-US" altLang="zh-CN" sz="1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l </a:t>
            </a:r>
            <a:r>
              <a:rPr lang="en-US" altLang="zh-CN" sz="14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howed the difference in Group IV.</a:t>
            </a:r>
            <a:endParaRPr lang="zh-CN" altLang="zh-CN" sz="14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53943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7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5</cp:revision>
  <dcterms:modified xsi:type="dcterms:W3CDTF">2017-10-20T01:01:45Z</dcterms:modified>
</cp:coreProperties>
</file>